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77BC97-75DD-4FCB-9248-CF4433BFA7A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22F219-A533-4DD1-9EBA-3C73A374CBC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407189-2B8F-475B-8629-E72EDFB1793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13610A-3780-4C56-897B-CB721775ABC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0D205D-1444-4E16-ABFC-C23529A01B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51F566-9552-4BEA-A8ED-335AC5B684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9E0B62-1EF0-43ED-B402-7200297E2E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3A752B-F408-46CC-8286-371BDAC0AF6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5E8F4C-99ED-4973-9619-B37BF3C9E4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E3CFEE-23BE-4F4B-A9B2-CCE660D038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D5B8B4-5455-481B-97EF-234332730C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40E2E9-0D41-4772-A8A1-228F161E91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738942C-9071-4792-9E63-08B0075309C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84"/>
          <p:cNvSpPr/>
          <p:nvPr/>
        </p:nvSpPr>
        <p:spPr>
          <a:xfrm>
            <a:off x="0" y="5638680"/>
            <a:ext cx="685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resentation 2.  Examples of the 1-5 scale used for the visual scoring of IDC in the hydroponic treatment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1" descr=""/>
          <p:cNvPicPr/>
          <p:nvPr/>
        </p:nvPicPr>
        <p:blipFill>
          <a:blip r:embed="rId1"/>
          <a:stretch/>
        </p:blipFill>
        <p:spPr>
          <a:xfrm>
            <a:off x="0" y="0"/>
            <a:ext cx="6858000" cy="5222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3-05T19:22:11Z</dcterms:created>
  <dc:creator>Robert M Stupar</dc:creator>
  <dc:description/>
  <dc:language>en-US</dc:language>
  <cp:lastModifiedBy>siva</cp:lastModifiedBy>
  <dcterms:modified xsi:type="dcterms:W3CDTF">2013-04-05T06:50:04Z</dcterms:modified>
  <cp:revision>1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hecked Out To">
    <vt:lpwstr/>
  </property>
  <property fmtid="{D5CDD505-2E9C-101B-9397-08002B2CF9AE}" pid="3" name="ContentTypeId">
    <vt:lpwstr>0x010100F725EE384B7A58499F7B801D4EF867A9</vt:lpwstr>
  </property>
  <property fmtid="{D5CDD505-2E9C-101B-9397-08002B2CF9AE}" pid="4" name="DocumentId">
    <vt:lpwstr>Presentation 2.PPTX</vt:lpwstr>
  </property>
  <property fmtid="{D5CDD505-2E9C-101B-9397-08002B2CF9AE}" pid="5" name="DocumentType">
    <vt:lpwstr>Presentation</vt:lpwstr>
  </property>
  <property fmtid="{D5CDD505-2E9C-101B-9397-08002B2CF9AE}" pid="6" name="FileFormat">
    <vt:lpwstr>PPTX</vt:lpwstr>
  </property>
  <property fmtid="{D5CDD505-2E9C-101B-9397-08002B2CF9AE}" pid="7" name="IsDeleted">
    <vt:lpwstr>0</vt:lpwstr>
  </property>
  <property fmtid="{D5CDD505-2E9C-101B-9397-08002B2CF9AE}" pid="8" name="StageName">
    <vt:lpwstr/>
  </property>
  <property fmtid="{D5CDD505-2E9C-101B-9397-08002B2CF9AE}" pid="9" name="TitleName">
    <vt:lpwstr>Presentation 2.PPTX</vt:lpwstr>
  </property>
</Properties>
</file>